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3" autoAdjust="0"/>
    <p:restoredTop sz="94660"/>
  </p:normalViewPr>
  <p:slideViewPr>
    <p:cSldViewPr snapToGrid="0">
      <p:cViewPr varScale="1">
        <p:scale>
          <a:sx n="77" d="100"/>
          <a:sy n="77" d="100"/>
        </p:scale>
        <p:origin x="76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CA48AE-83F4-4780-9886-DC831BD548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756D5A4-DC15-4EE5-9814-EF490C35B3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9F5AB4-B659-45A5-ACBE-9BEA757AA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0B5A20-E522-4F6A-ABAC-F872DAB63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BA1E13-252C-4924-A790-2324F6C64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9917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3FB8B4-944F-4CED-A8DF-8D73114E3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D3B454B-1386-4B17-9CB7-0602D5D4BA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503689-2DD0-4736-BF44-6850A5C77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080238-6FB5-4262-A8E7-139EB2F65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CC63AB-4097-49D4-8237-60B4590D9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7284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F72A933-3A12-44FD-A3E5-5C8F86741D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3D1ACE9-B9BA-4BCD-9487-BA4F87359F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83A380-A0C6-4927-86EE-61842CD56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C0FBD2-74C2-4A73-AEB7-D4758E9A8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306061-0C07-48E0-A980-0AD6B9DF0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4472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9615D7-D437-4CF0-ADA7-499BC7E108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528155-97B1-4EFB-8055-6A7F82CB9A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560D84-64A8-4E5F-BFAC-77364CD00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6A5852-CCB1-4CAE-8BC6-EBA07AD4B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94B773-8F9B-48AB-A496-546E7843A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2252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4E690B-C582-4B75-93D1-892820316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FB3E8D3-0F75-45AD-BDCC-9AEF395BE1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D67F2-6597-44C1-9B1E-77D138CBC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F35C33-8C16-4F34-962D-FEC1252D3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F41115-DF67-4813-94B4-E6B887392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1489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02A79E-7897-496A-A3FD-4B202DCBA2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A23FC1-163F-43CE-9C55-D3F29DB23C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C3126B3-71DE-48E4-9F53-C4C1ECE1A1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D2A8FB-4696-48A0-A302-642F6A01D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EE50C5-4ED4-47FC-BA50-DC18235D2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7BF3047-78B1-4CE0-A5B0-7633C8442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4056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94A850-E6B8-479C-9E7E-D373D00AA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76FFCC-0C2B-4C0A-BB04-28B152DFFB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F0458C-5EE3-4E5B-8BCB-355E685369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03D8AFC-1352-4939-AF47-5FBE51E106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058E1DC-5CC2-4738-9D4C-322BF18BC7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4404F66-A049-4964-BC07-258DD1709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0C904B8-946E-4B9D-9C06-571B1E6B8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BA80628-30F9-4A0B-8430-D5D551424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0307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D92E9D-9391-4E99-8158-34175D5DB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2F28C9-83BA-4FDC-9B6C-792A7132D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5E00CF9-88C0-4254-A219-498C95992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63B9483-0450-4D68-ABB1-A70D70821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056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5682EDB-5DB2-452C-A9DD-A561BED70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A8EAB85-E077-41BC-9154-9576B90AF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E826AD3-04D5-42FE-9E06-DDE068454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6325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469121-9131-4C0A-902A-00E9A7489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9568F8-1884-42C3-866B-869E27AF73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299A5A-98F6-4461-9E5B-2F63499DBE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1803E3-738B-47F9-94C7-66FC475FF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DACDD2-AA86-442B-B2EB-E8A8EB1A5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8187F7-D60D-44F6-84DF-DD4125B71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1520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376DC2-FDF1-4799-9E74-3F8679237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485B1FA-3176-46B9-B842-94FB4012B0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6930AF-809D-4AEA-A78D-8A5CA32E43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C68CF2-8275-47F7-B450-1C8C9E163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43F12F-B874-47CD-8222-7C323632A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BFDB6B-6979-4EAB-815D-26A3E7478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697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5BB69DF-1279-4661-B42A-0CA70B02F9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A4EB8BD-3F87-45D9-B8FF-C3A7806EC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A1C9BA-3854-4103-BD10-E14C6D4F85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84405-7CAA-4C3D-8B11-3ED1BE6A8FB2}" type="datetimeFigureOut">
              <a:rPr lang="zh-CN" altLang="en-US" smtClean="0"/>
              <a:t>2018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C855FB-FAD7-4437-93D4-7FBFF8979A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17398B-F51C-470B-B271-F961964E80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D7A26-A284-43AB-94C4-99BFCF6C31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112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CC7BF1F-5DA9-4E6A-820B-BA1DF6C330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4664" y="1013010"/>
            <a:ext cx="6074768" cy="3452501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B90F18EE-DFE0-4C68-AA4E-E4244DAF6B4E}"/>
              </a:ext>
            </a:extLst>
          </p:cNvPr>
          <p:cNvSpPr/>
          <p:nvPr/>
        </p:nvSpPr>
        <p:spPr>
          <a:xfrm>
            <a:off x="2648989" y="4657635"/>
            <a:ext cx="76006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Supplemental Figure 1: </a:t>
            </a:r>
            <a:r>
              <a:rPr lang="en-US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The stability of bacteriophage vB_EcoS-B2 under 4 °C</a:t>
            </a:r>
            <a:r>
              <a:rPr lang="zh-CN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，</a:t>
            </a:r>
            <a:r>
              <a:rPr lang="en-US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25 °C and 37 °C was determined for 7 days, the phage titer was not change much during 7 days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9779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7BD739C-C3B5-4416-91F9-ADE949006D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980" y="1041169"/>
            <a:ext cx="5551067" cy="3565286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DEA8A25A-C0E0-4204-8E11-A9014A68E03C}"/>
              </a:ext>
            </a:extLst>
          </p:cNvPr>
          <p:cNvSpPr/>
          <p:nvPr/>
        </p:nvSpPr>
        <p:spPr>
          <a:xfrm>
            <a:off x="3060020" y="4606455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Supplemental Figure 2: </a:t>
            </a:r>
            <a:r>
              <a:rPr lang="en-US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We usually determine the stability of vB_EcoS-B2 at 4 °C every week, this phage titer was not changed that much over 180 days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2401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88C1789-28F9-4A72-88CC-E7F19092F4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3271" y="836949"/>
            <a:ext cx="5470401" cy="3732953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9FCDFDE1-16C3-457E-8FCB-940F99D41E1C}"/>
              </a:ext>
            </a:extLst>
          </p:cNvPr>
          <p:cNvSpPr/>
          <p:nvPr/>
        </p:nvSpPr>
        <p:spPr>
          <a:xfrm>
            <a:off x="3222567" y="4926322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Supplemental Figure 3: </a:t>
            </a:r>
            <a:r>
              <a:rPr lang="en-US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It is Figure 2 was showed without the spots at each time point to see the SDs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854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4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1</cp:revision>
  <dcterms:created xsi:type="dcterms:W3CDTF">2018-04-18T03:40:40Z</dcterms:created>
  <dcterms:modified xsi:type="dcterms:W3CDTF">2018-04-18T03:42:58Z</dcterms:modified>
</cp:coreProperties>
</file>